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7"/>
  </p:notesMasterIdLst>
  <p:sldIdLst>
    <p:sldId id="256" r:id="rId5"/>
    <p:sldId id="258" r:id="rId6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0CC92"/>
    <a:srgbClr val="1C971D"/>
    <a:srgbClr val="F9696A"/>
    <a:srgbClr val="FBBCBD"/>
    <a:srgbClr val="ABC2E2"/>
    <a:srgbClr val="5A8AC6"/>
    <a:srgbClr val="FA696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BA8A7BE-9339-6E29-3B66-18211F44C34A}" v="12" dt="2025-12-03T14:40:24.72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806"/>
    <p:restoredTop sz="91268"/>
  </p:normalViewPr>
  <p:slideViewPr>
    <p:cSldViewPr snapToGrid="0">
      <p:cViewPr>
        <p:scale>
          <a:sx n="126" d="100"/>
          <a:sy n="126" d="100"/>
        </p:scale>
        <p:origin x="1368" y="-25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achel Edwards" userId="S::rachel.edwards@omniose.com::9526a979-b0ff-461c-b936-05f0a0158e0f" providerId="AD" clId="Web-{DBA8A7BE-9339-6E29-3B66-18211F44C34A}"/>
    <pc:docChg chg="modSld">
      <pc:chgData name="Rachel Edwards" userId="S::rachel.edwards@omniose.com::9526a979-b0ff-461c-b936-05f0a0158e0f" providerId="AD" clId="Web-{DBA8A7BE-9339-6E29-3B66-18211F44C34A}" dt="2025-12-03T14:40:23.557" v="5" actId="20577"/>
      <pc:docMkLst>
        <pc:docMk/>
      </pc:docMkLst>
      <pc:sldChg chg="modSp">
        <pc:chgData name="Rachel Edwards" userId="S::rachel.edwards@omniose.com::9526a979-b0ff-461c-b936-05f0a0158e0f" providerId="AD" clId="Web-{DBA8A7BE-9339-6E29-3B66-18211F44C34A}" dt="2025-12-03T14:40:23.557" v="5" actId="20577"/>
        <pc:sldMkLst>
          <pc:docMk/>
          <pc:sldMk cId="2756500991" sldId="258"/>
        </pc:sldMkLst>
        <pc:spChg chg="mod">
          <ac:chgData name="Rachel Edwards" userId="S::rachel.edwards@omniose.com::9526a979-b0ff-461c-b936-05f0a0158e0f" providerId="AD" clId="Web-{DBA8A7BE-9339-6E29-3B66-18211F44C34A}" dt="2025-12-03T14:40:23.557" v="5" actId="20577"/>
          <ac:spMkLst>
            <pc:docMk/>
            <pc:sldMk cId="2756500991" sldId="258"/>
            <ac:spMk id="3" creationId="{58C484F8-D2D2-437A-39EC-15BB584066E1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0A6CF9-E2FC-9046-8967-39F09EC4F788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F9FA02-4D04-9549-BFE4-4F65DD354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2591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6F9FA02-4D04-9549-BFE4-4F65DD35421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54129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8920057-05FE-67E4-3FCF-967C88EA86D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ACFC11E1-F96A-10A3-42B5-EDB6FBE93E46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4EF0851B-14BC-F02C-AF98-080169ECFA96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B5317C5-780C-36C0-7F6E-B297408ACDA2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6F9FA02-4D04-9549-BFE4-4F65DD35421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5991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F929C-A6AA-C045-B551-425F7B6CF004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4426-079D-F74D-AE20-531C4870C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0495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F929C-A6AA-C045-B551-425F7B6CF004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4426-079D-F74D-AE20-531C4870C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6264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F929C-A6AA-C045-B551-425F7B6CF004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4426-079D-F74D-AE20-531C4870C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70566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F929C-A6AA-C045-B551-425F7B6CF004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4426-079D-F74D-AE20-531C4870C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4165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>
                    <a:tint val="82000"/>
                  </a:schemeClr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82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82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F929C-A6AA-C045-B551-425F7B6CF004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4426-079D-F74D-AE20-531C4870C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9139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F929C-A6AA-C045-B551-425F7B6CF004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4426-079D-F74D-AE20-531C4870C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21869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F929C-A6AA-C045-B551-425F7B6CF004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4426-079D-F74D-AE20-531C4870C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5177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F929C-A6AA-C045-B551-425F7B6CF004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4426-079D-F74D-AE20-531C4870C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4964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F929C-A6AA-C045-B551-425F7B6CF004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4426-079D-F74D-AE20-531C4870C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67408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F929C-A6AA-C045-B551-425F7B6CF004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4426-079D-F74D-AE20-531C4870C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3781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F929C-A6AA-C045-B551-425F7B6CF004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D4426-079D-F74D-AE20-531C4870C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23251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46F929C-A6AA-C045-B551-425F7B6CF004}" type="datetimeFigureOut">
              <a:rPr lang="en-US" smtClean="0"/>
              <a:t>12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CD4426-079D-F74D-AE20-531C4870C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810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8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>
            <a:extLst>
              <a:ext uri="{FF2B5EF4-FFF2-40B4-BE49-F238E27FC236}">
                <a16:creationId xmlns:a16="http://schemas.microsoft.com/office/drawing/2014/main" id="{FA8DD5C4-B88C-23C2-E18D-BB1F2D4E8DE2}"/>
              </a:ext>
            </a:extLst>
          </p:cNvPr>
          <p:cNvSpPr txBox="1"/>
          <p:nvPr/>
        </p:nvSpPr>
        <p:spPr>
          <a:xfrm>
            <a:off x="144966" y="135924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D0792C2-CC72-3128-97DD-D9E62BD07B47}"/>
              </a:ext>
            </a:extLst>
          </p:cNvPr>
          <p:cNvSpPr txBox="1"/>
          <p:nvPr/>
        </p:nvSpPr>
        <p:spPr>
          <a:xfrm>
            <a:off x="5051502" y="13592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84D7A0B-5387-8D37-C09E-79B8D485B0A5}"/>
              </a:ext>
            </a:extLst>
          </p:cNvPr>
          <p:cNvSpPr txBox="1"/>
          <p:nvPr/>
        </p:nvSpPr>
        <p:spPr>
          <a:xfrm>
            <a:off x="144966" y="6211850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6F32D01-BC87-693F-C3DC-F7B7ABE1DAB1}"/>
              </a:ext>
            </a:extLst>
          </p:cNvPr>
          <p:cNvSpPr txBox="1"/>
          <p:nvPr/>
        </p:nvSpPr>
        <p:spPr>
          <a:xfrm>
            <a:off x="5051502" y="6211850"/>
            <a:ext cx="343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31BB057-3C66-462E-C62C-25636A90D3D3}"/>
              </a:ext>
            </a:extLst>
          </p:cNvPr>
          <p:cNvSpPr txBox="1"/>
          <p:nvPr/>
        </p:nvSpPr>
        <p:spPr>
          <a:xfrm>
            <a:off x="7090256" y="453781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late 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494BCD3-2F81-5DEC-44E6-2E5FE75A60A7}"/>
              </a:ext>
            </a:extLst>
          </p:cNvPr>
          <p:cNvSpPr txBox="1"/>
          <p:nvPr/>
        </p:nvSpPr>
        <p:spPr>
          <a:xfrm>
            <a:off x="6979649" y="6512106"/>
            <a:ext cx="8162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late 3A/B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2F2D341-E47C-08C3-8315-9292D29A842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6785" y="403624"/>
            <a:ext cx="4407308" cy="5633361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93199589-135C-FE5B-A9D1-5A6CDE720DA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54273" y="3283519"/>
            <a:ext cx="2667000" cy="406400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4AC01973-8165-850B-C919-F0494EE8CFD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54273" y="9926742"/>
            <a:ext cx="2667000" cy="406400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3D45EA04-CFAD-9FFF-A1C7-35A539849CD3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2122" t="2435"/>
          <a:stretch/>
        </p:blipFill>
        <p:spPr>
          <a:xfrm>
            <a:off x="5591543" y="689142"/>
            <a:ext cx="3592461" cy="2484427"/>
          </a:xfrm>
          <a:prstGeom prst="rect">
            <a:avLst/>
          </a:prstGeom>
        </p:spPr>
      </p:pic>
      <p:sp>
        <p:nvSpPr>
          <p:cNvPr id="41" name="Rectangle 40">
            <a:extLst>
              <a:ext uri="{FF2B5EF4-FFF2-40B4-BE49-F238E27FC236}">
                <a16:creationId xmlns:a16="http://schemas.microsoft.com/office/drawing/2014/main" id="{F476867A-A689-3F47-0861-00F294CE7CA0}"/>
              </a:ext>
            </a:extLst>
          </p:cNvPr>
          <p:cNvSpPr/>
          <p:nvPr/>
        </p:nvSpPr>
        <p:spPr>
          <a:xfrm>
            <a:off x="5525424" y="3140104"/>
            <a:ext cx="265245" cy="1099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3073D639-50DC-A739-441F-80642567C4C2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876" t="1509"/>
          <a:stretch/>
        </p:blipFill>
        <p:spPr>
          <a:xfrm>
            <a:off x="5558670" y="6758327"/>
            <a:ext cx="3658206" cy="307830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62DA8A7-E27B-1F5D-D452-D2CC076195B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8601" y="6512107"/>
            <a:ext cx="4415426" cy="60034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80741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15540C7-74A5-B18D-C9D6-135C39E70B3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>
            <a:extLst>
              <a:ext uri="{FF2B5EF4-FFF2-40B4-BE49-F238E27FC236}">
                <a16:creationId xmlns:a16="http://schemas.microsoft.com/office/drawing/2014/main" id="{64B0FB29-86E4-EAA6-12F5-4401E7AEB23D}"/>
              </a:ext>
            </a:extLst>
          </p:cNvPr>
          <p:cNvSpPr txBox="1"/>
          <p:nvPr/>
        </p:nvSpPr>
        <p:spPr>
          <a:xfrm>
            <a:off x="144966" y="191767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E0939E8-F86D-06D8-82AC-53FA9122C9C1}"/>
              </a:ext>
            </a:extLst>
          </p:cNvPr>
          <p:cNvSpPr txBox="1"/>
          <p:nvPr/>
        </p:nvSpPr>
        <p:spPr>
          <a:xfrm>
            <a:off x="5051502" y="191767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8C484F8-D2D2-437A-39EC-15BB584066E1}"/>
              </a:ext>
            </a:extLst>
          </p:cNvPr>
          <p:cNvSpPr txBox="1"/>
          <p:nvPr/>
        </p:nvSpPr>
        <p:spPr>
          <a:xfrm>
            <a:off x="144966" y="6515100"/>
            <a:ext cx="9266662" cy="2031325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marL="0" marR="0" algn="just"/>
            <a:r>
              <a:rPr lang="en-US" b="1" kern="100" dirty="0">
                <a:latin typeface="Arial"/>
                <a:ea typeface="Calibri"/>
                <a:cs typeface="Times New Roman"/>
              </a:rPr>
              <a:t>Figure</a:t>
            </a:r>
            <a:r>
              <a:rPr lang="en-US" sz="1800" b="1" kern="100" dirty="0">
                <a:effectLst/>
                <a:latin typeface="Arial"/>
                <a:ea typeface="Calibri"/>
                <a:cs typeface="Times New Roman"/>
              </a:rPr>
              <a:t> </a:t>
            </a:r>
            <a:r>
              <a:rPr lang="en-US" b="1" kern="100" dirty="0">
                <a:latin typeface="Arial"/>
                <a:ea typeface="Calibri"/>
                <a:cs typeface="Times New Roman"/>
              </a:rPr>
              <a:t>S3</a:t>
            </a:r>
            <a:r>
              <a:rPr lang="en-US" sz="1800" b="1" kern="100" dirty="0">
                <a:effectLst/>
                <a:latin typeface="Arial"/>
                <a:ea typeface="Calibri"/>
                <a:cs typeface="Times New Roman"/>
              </a:rPr>
              <a:t>. Combinatorial analysis of </a:t>
            </a:r>
            <a:r>
              <a:rPr lang="en-US" sz="1800" b="1" kern="100" dirty="0" err="1">
                <a:effectLst/>
                <a:latin typeface="Arial"/>
                <a:ea typeface="Calibri"/>
                <a:cs typeface="Times New Roman"/>
              </a:rPr>
              <a:t>PglS</a:t>
            </a:r>
            <a:r>
              <a:rPr lang="en-US" sz="1800" b="1" kern="100" dirty="0">
                <a:effectLst/>
                <a:latin typeface="Arial"/>
                <a:ea typeface="Calibri"/>
                <a:cs typeface="Times New Roman"/>
              </a:rPr>
              <a:t> hits identifies substitutions with improved GBSV glycan transfer ove</a:t>
            </a:r>
            <a:r>
              <a:rPr lang="en-US" b="1" kern="100" dirty="0">
                <a:latin typeface="Arial"/>
                <a:ea typeface="Calibri"/>
                <a:cs typeface="Times New Roman"/>
              </a:rPr>
              <a:t>r a single amino acid substitution.</a:t>
            </a:r>
            <a:r>
              <a:rPr lang="en-US" sz="1800" b="1" kern="100" dirty="0">
                <a:effectLst/>
                <a:latin typeface="Arial"/>
                <a:ea typeface="Calibri"/>
                <a:cs typeface="Times New Roman"/>
              </a:rPr>
              <a:t> </a:t>
            </a:r>
            <a:r>
              <a:rPr lang="en-US" sz="1800" kern="100" dirty="0">
                <a:effectLst/>
                <a:latin typeface="Arial"/>
                <a:ea typeface="Calibri"/>
                <a:cs typeface="Times New Roman"/>
              </a:rPr>
              <a:t>Panels A</a:t>
            </a:r>
            <a:r>
              <a:rPr lang="en-US" kern="100" dirty="0">
                <a:latin typeface="Arial"/>
                <a:ea typeface="Calibri"/>
                <a:cs typeface="Times New Roman"/>
              </a:rPr>
              <a:t>, C, and E depict </a:t>
            </a:r>
            <a:r>
              <a:rPr lang="en-US" sz="1800" kern="100" dirty="0">
                <a:effectLst/>
                <a:latin typeface="Arial"/>
                <a:ea typeface="Calibri"/>
                <a:cs typeface="Times New Roman"/>
              </a:rPr>
              <a:t>maps of the combinations of amino acids analyzed by sandwich ELISA. </a:t>
            </a:r>
            <a:r>
              <a:rPr lang="en-US" kern="100" dirty="0">
                <a:latin typeface="Arial"/>
                <a:ea typeface="Calibri"/>
                <a:cs typeface="Times New Roman"/>
              </a:rPr>
              <a:t>Panels B, D, and F show the </a:t>
            </a:r>
            <a:r>
              <a:rPr lang="en-US" sz="1800" kern="100" dirty="0">
                <a:effectLst/>
                <a:latin typeface="Arial"/>
                <a:ea typeface="Calibri"/>
                <a:cs typeface="Times New Roman"/>
              </a:rPr>
              <a:t>heatmaps of the fold changes in ELISA signals for the combinatorial substitutions compared to wildtype </a:t>
            </a:r>
            <a:r>
              <a:rPr lang="en-US" sz="1800" kern="100" dirty="0" err="1">
                <a:effectLst/>
                <a:latin typeface="Arial"/>
                <a:ea typeface="Calibri"/>
                <a:cs typeface="Times New Roman"/>
              </a:rPr>
              <a:t>PglS</a:t>
            </a:r>
            <a:r>
              <a:rPr lang="en-US" sz="1800" kern="100" dirty="0">
                <a:effectLst/>
                <a:latin typeface="Arial"/>
                <a:ea typeface="Calibri"/>
                <a:cs typeface="Times New Roman"/>
              </a:rPr>
              <a:t> as explained in the color key. Wells in the heatmaps correspond to the combinations listed in adjacent panels. Grey indicates empty wells. </a:t>
            </a:r>
            <a:r>
              <a:rPr lang="en-US" kern="100" dirty="0">
                <a:latin typeface="Arial"/>
                <a:ea typeface="Calibri"/>
                <a:cs typeface="Times New Roman"/>
              </a:rPr>
              <a:t>F</a:t>
            </a:r>
            <a:r>
              <a:rPr lang="en-US" sz="1800" kern="100" dirty="0">
                <a:effectLst/>
                <a:latin typeface="Arial"/>
                <a:ea typeface="Calibri"/>
                <a:cs typeface="Times New Roman"/>
              </a:rPr>
              <a:t>old changes represent the mean from at least 2 independent experiments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7D7FA8B-9CAB-FE24-2F5F-1B004EFDAF8A}"/>
              </a:ext>
            </a:extLst>
          </p:cNvPr>
          <p:cNvSpPr txBox="1"/>
          <p:nvPr/>
        </p:nvSpPr>
        <p:spPr>
          <a:xfrm>
            <a:off x="7056672" y="484475"/>
            <a:ext cx="8162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late 4A/B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0D7B9EC3-D30B-22DC-C1F7-FE1A4DF944A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31296" y="3889435"/>
            <a:ext cx="2667000" cy="4064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B2AE8FB-C872-5EFB-BAB6-558B39AA459A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000" t="2040"/>
          <a:stretch/>
        </p:blipFill>
        <p:spPr>
          <a:xfrm>
            <a:off x="5635653" y="730696"/>
            <a:ext cx="3658286" cy="306566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94A4F16-DBBF-57EC-3A03-580174114B0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5501" y="484474"/>
            <a:ext cx="4174197" cy="57847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65009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MigrationWizIdVersion xmlns="324db12f-297c-40e3-86f6-4d82186512ff" xsi:nil="true"/>
    <lcf76f155ced4ddcb4097134ff3c332f xmlns="324db12f-297c-40e3-86f6-4d82186512ff">
      <Terms xmlns="http://schemas.microsoft.com/office/infopath/2007/PartnerControls"/>
    </lcf76f155ced4ddcb4097134ff3c332f>
    <MigrationWizIdPermissions xmlns="324db12f-297c-40e3-86f6-4d82186512ff" xsi:nil="true"/>
    <MigrationWizId xmlns="324db12f-297c-40e3-86f6-4d82186512ff" xsi:nil="true"/>
    <TaxCatchAll xmlns="28e55284-abd9-4569-8d7b-f719476aa490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8E8871314C8434FB52206FC0D75AEC5" ma:contentTypeVersion="15" ma:contentTypeDescription="Create a new document." ma:contentTypeScope="" ma:versionID="9669befa45aa3885246f648b2dbc40ad">
  <xsd:schema xmlns:xsd="http://www.w3.org/2001/XMLSchema" xmlns:xs="http://www.w3.org/2001/XMLSchema" xmlns:p="http://schemas.microsoft.com/office/2006/metadata/properties" xmlns:ns2="324db12f-297c-40e3-86f6-4d82186512ff" xmlns:ns3="28e55284-abd9-4569-8d7b-f719476aa490" targetNamespace="http://schemas.microsoft.com/office/2006/metadata/properties" ma:root="true" ma:fieldsID="82e65c3b09da1b7f028bd4253ea4a73e" ns2:_="" ns3:_="">
    <xsd:import namespace="324db12f-297c-40e3-86f6-4d82186512ff"/>
    <xsd:import namespace="28e55284-abd9-4569-8d7b-f719476aa490"/>
    <xsd:element name="properties">
      <xsd:complexType>
        <xsd:sequence>
          <xsd:element name="documentManagement">
            <xsd:complexType>
              <xsd:all>
                <xsd:element ref="ns2:MigrationWizId" minOccurs="0"/>
                <xsd:element ref="ns2:MigrationWizIdPermissions" minOccurs="0"/>
                <xsd:element ref="ns2:MigrationWizIdVersion" minOccurs="0"/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24db12f-297c-40e3-86f6-4d82186512ff" elementFormDefault="qualified">
    <xsd:import namespace="http://schemas.microsoft.com/office/2006/documentManagement/types"/>
    <xsd:import namespace="http://schemas.microsoft.com/office/infopath/2007/PartnerControls"/>
    <xsd:element name="MigrationWizId" ma:index="8" nillable="true" ma:displayName="MigrationWizId" ma:internalName="MigrationWizId">
      <xsd:simpleType>
        <xsd:restriction base="dms:Text"/>
      </xsd:simpleType>
    </xsd:element>
    <xsd:element name="MigrationWizIdPermissions" ma:index="9" nillable="true" ma:displayName="MigrationWizIdPermissions" ma:internalName="MigrationWizIdPermissions">
      <xsd:simpleType>
        <xsd:restriction base="dms:Text"/>
      </xsd:simpleType>
    </xsd:element>
    <xsd:element name="MigrationWizIdVersion" ma:index="10" nillable="true" ma:displayName="MigrationWizIdVersion" ma:internalName="MigrationWizIdVersion">
      <xsd:simpleType>
        <xsd:restriction base="dms:Text"/>
      </xsd:simpleType>
    </xsd:element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3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6" nillable="true" ma:taxonomy="true" ma:internalName="lcf76f155ced4ddcb4097134ff3c332f" ma:taxonomyFieldName="MediaServiceImageTags" ma:displayName="Image Tags" ma:readOnly="false" ma:fieldId="{5cf76f15-5ced-4ddc-b409-7134ff3c332f}" ma:taxonomyMulti="true" ma:sspId="d6ac3562-be2b-463b-9688-fb9859eb15c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8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20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1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22" nillable="true" ma:displayName="Location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8e55284-abd9-4569-8d7b-f719476aa490" elementFormDefault="qualified">
    <xsd:import namespace="http://schemas.microsoft.com/office/2006/documentManagement/types"/>
    <xsd:import namespace="http://schemas.microsoft.com/office/infopath/2007/PartnerControls"/>
    <xsd:element name="TaxCatchAll" ma:index="17" nillable="true" ma:displayName="Taxonomy Catch All Column" ma:hidden="true" ma:list="{652b7d07-4398-489a-9ec2-57654188717d}" ma:internalName="TaxCatchAll" ma:showField="CatchAllData" ma:web="28e55284-abd9-4569-8d7b-f719476aa490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23EDEE3D-AB4A-4E86-9C04-5DB171E65781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6761C9CB-C864-4682-8F22-66CC1CB07268}">
  <ds:schemaRefs>
    <ds:schemaRef ds:uri="http://schemas.microsoft.com/office/2006/documentManagement/types"/>
    <ds:schemaRef ds:uri="324db12f-297c-40e3-86f6-4d82186512ff"/>
    <ds:schemaRef ds:uri="http://purl.org/dc/terms/"/>
    <ds:schemaRef ds:uri="http://purl.org/dc/elements/1.1/"/>
    <ds:schemaRef ds:uri="http://purl.org/dc/dcmitype/"/>
    <ds:schemaRef ds:uri="http://www.w3.org/XML/1998/namespace"/>
    <ds:schemaRef ds:uri="28e55284-abd9-4569-8d7b-f719476aa490"/>
    <ds:schemaRef ds:uri="http://schemas.microsoft.com/office/infopath/2007/PartnerControls"/>
    <ds:schemaRef ds:uri="http://schemas.openxmlformats.org/package/2006/metadata/core-properties"/>
    <ds:schemaRef ds:uri="http://schemas.microsoft.com/office/2006/metadata/properties"/>
  </ds:schemaRefs>
</ds:datastoreItem>
</file>

<file path=customXml/itemProps3.xml><?xml version="1.0" encoding="utf-8"?>
<ds:datastoreItem xmlns:ds="http://schemas.openxmlformats.org/officeDocument/2006/customXml" ds:itemID="{D944969F-04A2-4B9B-A151-9F2C9F55AC8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24db12f-297c-40e3-86f6-4d82186512ff"/>
    <ds:schemaRef ds:uri="28e55284-abd9-4569-8d7b-f719476aa49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39</TotalTime>
  <Words>123</Words>
  <Application>Microsoft Office PowerPoint</Application>
  <PresentationFormat>A3 Paper (297x420 mm)</PresentationFormat>
  <Paragraphs>12</Paragraphs>
  <Slides>2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chel Edwards</dc:creator>
  <cp:lastModifiedBy>Rachel Edwards</cp:lastModifiedBy>
  <cp:revision>3</cp:revision>
  <dcterms:created xsi:type="dcterms:W3CDTF">2025-01-22T18:46:44Z</dcterms:created>
  <dcterms:modified xsi:type="dcterms:W3CDTF">2025-12-03T14:40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8E8871314C8434FB52206FC0D75AEC5</vt:lpwstr>
  </property>
  <property fmtid="{D5CDD505-2E9C-101B-9397-08002B2CF9AE}" pid="3" name="MediaServiceImageTags">
    <vt:lpwstr/>
  </property>
</Properties>
</file>